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9207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838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9406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7222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209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1623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1845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90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5445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70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4777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8616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801" y="1066801"/>
            <a:ext cx="4126279" cy="5378269"/>
          </a:xfrm>
        </p:spPr>
      </p:pic>
      <p:sp>
        <p:nvSpPr>
          <p:cNvPr id="5" name="TextBox 4"/>
          <p:cNvSpPr txBox="1"/>
          <p:nvPr/>
        </p:nvSpPr>
        <p:spPr>
          <a:xfrm>
            <a:off x="1645920" y="152401"/>
            <a:ext cx="8763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solidFill>
                  <a:prstClr val="black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S3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Figure: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PCR validation of representative up-regulated (KRT6B, SERPINB, CCL22, DEFB4 and S100A8) and down-regulated (CST6, CLDN23 and LOR) genes in a mouse model of atopic dermatitis</a:t>
            </a:r>
            <a:endParaRPr lang="en-US" sz="16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1403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urwilo</dc:creator>
  <cp:lastModifiedBy>Douglas Surwilo</cp:lastModifiedBy>
  <cp:revision>1</cp:revision>
  <dcterms:created xsi:type="dcterms:W3CDTF">2015-12-11T19:51:52Z</dcterms:created>
  <dcterms:modified xsi:type="dcterms:W3CDTF">2015-12-11T19:52:10Z</dcterms:modified>
</cp:coreProperties>
</file>